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fntdata" ContentType="application/x-fontdata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4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>
  <p:sldMasterIdLst>
    <p:sldMasterId id="2147483648" r:id="rId1"/>
  </p:sldMasterIdLst>
  <p:sldIdLst>
    <p:sldId id="259" r:id="rId2"/>
  </p:sldIdLst>
  <p:sldSz cx="12192000" cy="6858000"/>
  <p:notesSz cx="6858000" cy="9144000"/>
  <p:embeddedFontLst>
    <p:embeddedFont>
      <p:font typeface="Calibri" panose="020F0502020204030204" pitchFamily="34" charset="0"/>
      <p:regular r:id="rId3"/>
      <p:bold r:id="rId4"/>
      <p:italic r:id="rId5"/>
      <p:boldItalic r:id="rId6"/>
    </p:embeddedFont>
    <p:embeddedFont>
      <p:font typeface="Calibri Light" panose="020F0302020204030204" pitchFamily="34" charset="0"/>
      <p:regular r:id="rId7"/>
      <p:italic r:id="rId8"/>
    </p:embeddedFont>
  </p:embeddedFontLst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 showGuides="1">
      <p:cViewPr varScale="1">
        <p:scale>
          <a:sx n="116" d="100"/>
          <a:sy n="116" d="100"/>
        </p:scale>
        <p:origin x="138" y="3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6.fntdata"/><Relationship Id="rId3" Type="http://schemas.openxmlformats.org/officeDocument/2006/relationships/font" Target="fonts/font1.fntdata"/><Relationship Id="rId7" Type="http://schemas.openxmlformats.org/officeDocument/2006/relationships/font" Target="fonts/font5.fntdata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4.fntdata"/><Relationship Id="rId11" Type="http://schemas.openxmlformats.org/officeDocument/2006/relationships/theme" Target="theme/theme1.xml"/><Relationship Id="rId5" Type="http://schemas.openxmlformats.org/officeDocument/2006/relationships/font" Target="fonts/font3.fntdata"/><Relationship Id="rId10" Type="http://schemas.openxmlformats.org/officeDocument/2006/relationships/viewProps" Target="viewProps.xml"/><Relationship Id="rId4" Type="http://schemas.openxmlformats.org/officeDocument/2006/relationships/font" Target="fonts/font2.fntdata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-Arbeitsblatt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Microsoft_Excel-Arbeitsblatt1.xlsx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package" Target="../embeddings/Microsoft_Excel-Arbeitsblatt2.xlsx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package" Target="../embeddings/Microsoft_Excel-Arbeitsblatt3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AT"/>
              <a:t>negative</a:t>
            </a:r>
            <a:r>
              <a:rPr lang="de-AT" baseline="0"/>
              <a:t> control</a:t>
            </a:r>
            <a:endParaRPr lang="de-AT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lineChart>
        <c:grouping val="standard"/>
        <c:varyColors val="0"/>
        <c:ser>
          <c:idx val="5"/>
          <c:order val="5"/>
          <c:tx>
            <c:strRef>
              <c:f>'TCRgd graphs'!$Q$9</c:f>
              <c:strCache>
                <c:ptCount val="1"/>
                <c:pt idx="0">
                  <c:v>mean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'TCRgd graphs'!$R$3:$W$3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cat>
          <c:val>
            <c:numRef>
              <c:f>'TCRgd graphs'!$R$9:$W$9</c:f>
              <c:numCache>
                <c:formatCode>General</c:formatCode>
                <c:ptCount val="6"/>
                <c:pt idx="0">
                  <c:v>102093.8336</c:v>
                </c:pt>
                <c:pt idx="1">
                  <c:v>253072.89799999999</c:v>
                </c:pt>
                <c:pt idx="2">
                  <c:v>393449.94000000006</c:v>
                </c:pt>
                <c:pt idx="3">
                  <c:v>433247.72600000008</c:v>
                </c:pt>
                <c:pt idx="4">
                  <c:v>369115.16489696968</c:v>
                </c:pt>
                <c:pt idx="5">
                  <c:v>454633.334999999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37B-4DB4-811E-3EDCF62A052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43384416"/>
        <c:axId val="443385072"/>
      </c:lineChart>
      <c:scatterChart>
        <c:scatterStyle val="lineMarker"/>
        <c:varyColors val="0"/>
        <c:ser>
          <c:idx val="0"/>
          <c:order val="0"/>
          <c:tx>
            <c:strRef>
              <c:f>'TCRgd graphs'!$Q$4</c:f>
              <c:strCache>
                <c:ptCount val="1"/>
                <c:pt idx="0">
                  <c:v>1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strRef>
              <c:f>'TCRgd graphs'!$R$3:$W$3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TCRgd graphs'!$R$4:$W$4</c:f>
              <c:numCache>
                <c:formatCode>General</c:formatCode>
                <c:ptCount val="6"/>
                <c:pt idx="0">
                  <c:v>145368.29999999999</c:v>
                </c:pt>
                <c:pt idx="1">
                  <c:v>246707.66</c:v>
                </c:pt>
                <c:pt idx="2">
                  <c:v>304871.90000000002</c:v>
                </c:pt>
                <c:pt idx="3">
                  <c:v>371386.88</c:v>
                </c:pt>
                <c:pt idx="4">
                  <c:v>356625.2300000001</c:v>
                </c:pt>
                <c:pt idx="5">
                  <c:v>47684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137B-4DB4-811E-3EDCF62A052A}"/>
            </c:ext>
          </c:extLst>
        </c:ser>
        <c:ser>
          <c:idx val="1"/>
          <c:order val="1"/>
          <c:tx>
            <c:strRef>
              <c:f>'TCRgd graphs'!$Q$5</c:f>
              <c:strCache>
                <c:ptCount val="1"/>
                <c:pt idx="0">
                  <c:v>2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strRef>
              <c:f>'TCRgd graphs'!$R$3:$W$3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TCRgd graphs'!$R$5:$W$5</c:f>
              <c:numCache>
                <c:formatCode>General</c:formatCode>
                <c:ptCount val="6"/>
                <c:pt idx="0">
                  <c:v>65943.063999999998</c:v>
                </c:pt>
                <c:pt idx="1">
                  <c:v>325950.48</c:v>
                </c:pt>
                <c:pt idx="2">
                  <c:v>309533.40000000002</c:v>
                </c:pt>
                <c:pt idx="3">
                  <c:v>596725.03800000006</c:v>
                </c:pt>
                <c:pt idx="4">
                  <c:v>251991.25</c:v>
                </c:pt>
                <c:pt idx="5">
                  <c:v>561933.6999999999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137B-4DB4-811E-3EDCF62A052A}"/>
            </c:ext>
          </c:extLst>
        </c:ser>
        <c:ser>
          <c:idx val="2"/>
          <c:order val="2"/>
          <c:tx>
            <c:strRef>
              <c:f>'TCRgd graphs'!$Q$6</c:f>
              <c:strCache>
                <c:ptCount val="1"/>
                <c:pt idx="0">
                  <c:v>3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strRef>
              <c:f>'TCRgd graphs'!$R$3:$W$3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TCRgd graphs'!$R$6:$W$6</c:f>
              <c:numCache>
                <c:formatCode>General</c:formatCode>
                <c:ptCount val="6"/>
                <c:pt idx="0">
                  <c:v>33904.332000000002</c:v>
                </c:pt>
                <c:pt idx="1">
                  <c:v>221312.91</c:v>
                </c:pt>
                <c:pt idx="2">
                  <c:v>448676.80000000005</c:v>
                </c:pt>
                <c:pt idx="3">
                  <c:v>312702.76200000005</c:v>
                </c:pt>
                <c:pt idx="4">
                  <c:v>577365.16266666679</c:v>
                </c:pt>
                <c:pt idx="5">
                  <c:v>325119.3049999999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137B-4DB4-811E-3EDCF62A052A}"/>
            </c:ext>
          </c:extLst>
        </c:ser>
        <c:ser>
          <c:idx val="3"/>
          <c:order val="3"/>
          <c:tx>
            <c:strRef>
              <c:f>'TCRgd graphs'!$Q$7</c:f>
              <c:strCache>
                <c:ptCount val="1"/>
                <c:pt idx="0">
                  <c:v>4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strRef>
              <c:f>'TCRgd graphs'!$R$3:$W$3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TCRgd graphs'!$R$7:$W$7</c:f>
              <c:numCache>
                <c:formatCode>General</c:formatCode>
                <c:ptCount val="6"/>
                <c:pt idx="0">
                  <c:v>67388.112000000008</c:v>
                </c:pt>
                <c:pt idx="1">
                  <c:v>189476</c:v>
                </c:pt>
                <c:pt idx="2">
                  <c:v>421537.2</c:v>
                </c:pt>
                <c:pt idx="3">
                  <c:v>445237.45</c:v>
                </c:pt>
                <c:pt idx="4">
                  <c:v>392373.8181818181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137B-4DB4-811E-3EDCF62A052A}"/>
            </c:ext>
          </c:extLst>
        </c:ser>
        <c:ser>
          <c:idx val="4"/>
          <c:order val="4"/>
          <c:tx>
            <c:strRef>
              <c:f>'TCRgd graphs'!$Q$8</c:f>
              <c:strCache>
                <c:ptCount val="1"/>
                <c:pt idx="0">
                  <c:v>5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strRef>
              <c:f>'TCRgd graphs'!$R$3:$W$3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TCRgd graphs'!$R$8:$W$8</c:f>
              <c:numCache>
                <c:formatCode>General</c:formatCode>
                <c:ptCount val="6"/>
                <c:pt idx="0">
                  <c:v>197865.36</c:v>
                </c:pt>
                <c:pt idx="1">
                  <c:v>281917.43999999994</c:v>
                </c:pt>
                <c:pt idx="2">
                  <c:v>482630.40000000002</c:v>
                </c:pt>
                <c:pt idx="3">
                  <c:v>440186.50000000006</c:v>
                </c:pt>
                <c:pt idx="4">
                  <c:v>267220.3636363636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137B-4DB4-811E-3EDCF62A052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96886784"/>
        <c:axId val="496886456"/>
      </c:scatterChart>
      <c:catAx>
        <c:axId val="4433844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43385072"/>
        <c:crosses val="autoZero"/>
        <c:auto val="1"/>
        <c:lblAlgn val="ctr"/>
        <c:lblOffset val="100"/>
        <c:noMultiLvlLbl val="0"/>
      </c:catAx>
      <c:valAx>
        <c:axId val="443385072"/>
        <c:scaling>
          <c:orientation val="minMax"/>
          <c:max val="4000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43384416"/>
        <c:crosses val="autoZero"/>
        <c:crossBetween val="between"/>
        <c:majorUnit val="1000000"/>
        <c:dispUnits>
          <c:builtInUnit val="hundredThousands"/>
          <c:dispUnitsLbl>
            <c:layout>
              <c:manualLayout>
                <c:xMode val="edge"/>
                <c:yMode val="edge"/>
                <c:x val="2.1911663216011044E-2"/>
                <c:y val="0.38563156100886165"/>
              </c:manualLayout>
            </c:layout>
            <c:tx>
              <c:rich>
                <a:bodyPr rot="-5400000" spcFirstLastPara="1" vertOverflow="ellipsis" vert="horz" wrap="square" anchor="ctr" anchorCtr="1"/>
                <a:lstStyle/>
                <a:p>
                  <a:pPr>
                    <a:defRPr sz="10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r>
                    <a:rPr lang="de-AT" sz="1000">
                      <a:effectLst/>
                    </a:rPr>
                    <a:t>10</a:t>
                  </a:r>
                  <a:r>
                    <a:rPr lang="de-AT" sz="1000" baseline="30000">
                      <a:effectLst/>
                    </a:rPr>
                    <a:t>5 </a:t>
                  </a:r>
                  <a:r>
                    <a:rPr lang="de-AT" sz="1000" b="0" i="0" u="none" strike="noStrike" baseline="0">
                      <a:effectLst/>
                    </a:rPr>
                    <a:t>cells</a:t>
                  </a:r>
                  <a:r>
                    <a:rPr lang="de-AT" sz="1000">
                      <a:effectLst/>
                    </a:rPr>
                    <a:t>/ml</a:t>
                  </a:r>
                </a:p>
              </c:rich>
            </c:tx>
            <c:spPr>
              <a:noFill/>
              <a:ln>
                <a:noFill/>
              </a:ln>
              <a:effectLst/>
            </c:spPr>
            <c:txPr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</c:dispUnitsLbl>
        </c:dispUnits>
      </c:valAx>
      <c:valAx>
        <c:axId val="496886456"/>
        <c:scaling>
          <c:orientation val="minMax"/>
          <c:max val="4000000"/>
        </c:scaling>
        <c:delete val="1"/>
        <c:axPos val="r"/>
        <c:numFmt formatCode="General" sourceLinked="1"/>
        <c:majorTickMark val="out"/>
        <c:minorTickMark val="none"/>
        <c:tickLblPos val="nextTo"/>
        <c:crossAx val="496886784"/>
        <c:crosses val="max"/>
        <c:crossBetween val="midCat"/>
      </c:valAx>
      <c:valAx>
        <c:axId val="496886784"/>
        <c:scaling>
          <c:orientation val="minMax"/>
        </c:scaling>
        <c:delete val="1"/>
        <c:axPos val="t"/>
        <c:majorTickMark val="out"/>
        <c:minorTickMark val="none"/>
        <c:tickLblPos val="nextTo"/>
        <c:crossAx val="496886456"/>
        <c:crosses val="max"/>
        <c:crossBetween val="midCat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AT"/>
              <a:t>vaccination-only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lineChart>
        <c:grouping val="standard"/>
        <c:varyColors val="0"/>
        <c:ser>
          <c:idx val="5"/>
          <c:order val="5"/>
          <c:tx>
            <c:strRef>
              <c:f>'TCRgd graphs'!$Q$19</c:f>
              <c:strCache>
                <c:ptCount val="1"/>
                <c:pt idx="0">
                  <c:v>mean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'TCRgd graphs'!$R$13:$W$13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cat>
          <c:val>
            <c:numRef>
              <c:f>'TCRgd graphs'!$R$19:$W$19</c:f>
              <c:numCache>
                <c:formatCode>General</c:formatCode>
                <c:ptCount val="6"/>
                <c:pt idx="0">
                  <c:v>260233.00200000004</c:v>
                </c:pt>
                <c:pt idx="1">
                  <c:v>462612.24900000001</c:v>
                </c:pt>
                <c:pt idx="2">
                  <c:v>995911.41999999993</c:v>
                </c:pt>
                <c:pt idx="3">
                  <c:v>915412.5780000001</c:v>
                </c:pt>
                <c:pt idx="4">
                  <c:v>266562.3554</c:v>
                </c:pt>
                <c:pt idx="5">
                  <c:v>708572.5673333333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D06-4E87-A5D7-B2B4BF3BF93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20649176"/>
        <c:axId val="420646880"/>
      </c:lineChart>
      <c:scatterChart>
        <c:scatterStyle val="lineMarker"/>
        <c:varyColors val="0"/>
        <c:ser>
          <c:idx val="0"/>
          <c:order val="0"/>
          <c:tx>
            <c:strRef>
              <c:f>'TCRgd graphs'!$Q$14</c:f>
              <c:strCache>
                <c:ptCount val="1"/>
                <c:pt idx="0">
                  <c:v>6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strRef>
              <c:f>'TCRgd graphs'!$R$13:$W$13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TCRgd graphs'!$R$14:$W$14</c:f>
              <c:numCache>
                <c:formatCode>General</c:formatCode>
                <c:ptCount val="6"/>
                <c:pt idx="0">
                  <c:v>19122.349999999999</c:v>
                </c:pt>
                <c:pt idx="1">
                  <c:v>657489</c:v>
                </c:pt>
                <c:pt idx="2">
                  <c:v>898914.75</c:v>
                </c:pt>
                <c:pt idx="3">
                  <c:v>1146193.6200000003</c:v>
                </c:pt>
                <c:pt idx="4">
                  <c:v>263199.55199999997</c:v>
                </c:pt>
                <c:pt idx="5">
                  <c:v>1294805.5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FD06-4E87-A5D7-B2B4BF3BF931}"/>
            </c:ext>
          </c:extLst>
        </c:ser>
        <c:ser>
          <c:idx val="1"/>
          <c:order val="1"/>
          <c:tx>
            <c:strRef>
              <c:f>'TCRgd graphs'!$Q$15</c:f>
              <c:strCache>
                <c:ptCount val="1"/>
                <c:pt idx="0">
                  <c:v>7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strRef>
              <c:f>'TCRgd graphs'!$R$13:$W$13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TCRgd graphs'!$R$15:$W$15</c:f>
              <c:numCache>
                <c:formatCode>General</c:formatCode>
                <c:ptCount val="6"/>
                <c:pt idx="0">
                  <c:v>1050713.6000000001</c:v>
                </c:pt>
                <c:pt idx="1">
                  <c:v>324733.5</c:v>
                </c:pt>
                <c:pt idx="2">
                  <c:v>793881</c:v>
                </c:pt>
                <c:pt idx="3">
                  <c:v>510622.2</c:v>
                </c:pt>
                <c:pt idx="4">
                  <c:v>255069.71500000003</c:v>
                </c:pt>
                <c:pt idx="5">
                  <c:v>446879.6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FD06-4E87-A5D7-B2B4BF3BF931}"/>
            </c:ext>
          </c:extLst>
        </c:ser>
        <c:ser>
          <c:idx val="2"/>
          <c:order val="2"/>
          <c:tx>
            <c:strRef>
              <c:f>'TCRgd graphs'!$Q$16</c:f>
              <c:strCache>
                <c:ptCount val="1"/>
                <c:pt idx="0">
                  <c:v>8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strRef>
              <c:f>'TCRgd graphs'!$R$13:$W$13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TCRgd graphs'!$R$16:$W$16</c:f>
              <c:numCache>
                <c:formatCode>General</c:formatCode>
                <c:ptCount val="6"/>
                <c:pt idx="0">
                  <c:v>67876.479999999996</c:v>
                </c:pt>
                <c:pt idx="1">
                  <c:v>525361.74500000011</c:v>
                </c:pt>
                <c:pt idx="2">
                  <c:v>609739.65000000014</c:v>
                </c:pt>
                <c:pt idx="3">
                  <c:v>1309931.9999999998</c:v>
                </c:pt>
                <c:pt idx="4">
                  <c:v>21085.35</c:v>
                </c:pt>
                <c:pt idx="5">
                  <c:v>384032.502000000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FD06-4E87-A5D7-B2B4BF3BF931}"/>
            </c:ext>
          </c:extLst>
        </c:ser>
        <c:ser>
          <c:idx val="3"/>
          <c:order val="3"/>
          <c:tx>
            <c:strRef>
              <c:f>'TCRgd graphs'!$Q$17</c:f>
              <c:strCache>
                <c:ptCount val="1"/>
                <c:pt idx="0">
                  <c:v>9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strRef>
              <c:f>'TCRgd graphs'!$R$13:$W$13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TCRgd graphs'!$R$17:$W$17</c:f>
              <c:numCache>
                <c:formatCode>General</c:formatCode>
                <c:ptCount val="6"/>
                <c:pt idx="0">
                  <c:v>81555.100000000006</c:v>
                </c:pt>
                <c:pt idx="1">
                  <c:v>242112.64000000001</c:v>
                </c:pt>
                <c:pt idx="2">
                  <c:v>864695.3</c:v>
                </c:pt>
                <c:pt idx="3">
                  <c:v>714538.44</c:v>
                </c:pt>
                <c:pt idx="4">
                  <c:v>54181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FD06-4E87-A5D7-B2B4BF3BF931}"/>
            </c:ext>
          </c:extLst>
        </c:ser>
        <c:ser>
          <c:idx val="4"/>
          <c:order val="4"/>
          <c:tx>
            <c:strRef>
              <c:f>'TCRgd graphs'!$Q$18</c:f>
              <c:strCache>
                <c:ptCount val="1"/>
                <c:pt idx="0">
                  <c:v>10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strRef>
              <c:f>'TCRgd graphs'!$R$13:$W$13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TCRgd graphs'!$R$18:$W$18</c:f>
              <c:numCache>
                <c:formatCode>General</c:formatCode>
                <c:ptCount val="6"/>
                <c:pt idx="0">
                  <c:v>81897.48000000001</c:v>
                </c:pt>
                <c:pt idx="1">
                  <c:v>563364.36</c:v>
                </c:pt>
                <c:pt idx="2">
                  <c:v>1812326.3999999999</c:v>
                </c:pt>
                <c:pt idx="3">
                  <c:v>895776.63</c:v>
                </c:pt>
                <c:pt idx="4">
                  <c:v>251642.1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FD06-4E87-A5D7-B2B4BF3BF93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22154704"/>
        <c:axId val="422154048"/>
      </c:scatterChart>
      <c:catAx>
        <c:axId val="4206491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20646880"/>
        <c:crosses val="autoZero"/>
        <c:auto val="1"/>
        <c:lblAlgn val="ctr"/>
        <c:lblOffset val="100"/>
        <c:noMultiLvlLbl val="0"/>
      </c:catAx>
      <c:valAx>
        <c:axId val="420646880"/>
        <c:scaling>
          <c:orientation val="minMax"/>
          <c:max val="4000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20649176"/>
        <c:crosses val="autoZero"/>
        <c:crossBetween val="between"/>
        <c:majorUnit val="1000000"/>
        <c:dispUnits>
          <c:builtInUnit val="hundredThousands"/>
          <c:dispUnitsLbl>
            <c:layout>
              <c:manualLayout>
                <c:xMode val="edge"/>
                <c:yMode val="edge"/>
                <c:x val="2.6780921708457941E-2"/>
                <c:y val="0.38563156100886165"/>
              </c:manualLayout>
            </c:layout>
            <c:tx>
              <c:rich>
                <a:bodyPr rot="-5400000" spcFirstLastPara="1" vertOverflow="ellipsis" vert="horz" wrap="square" anchor="ctr" anchorCtr="1"/>
                <a:lstStyle/>
                <a:p>
                  <a:pPr>
                    <a:defRPr sz="10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r>
                    <a:rPr lang="de-AT" sz="1000">
                      <a:effectLst/>
                    </a:rPr>
                    <a:t>10</a:t>
                  </a:r>
                  <a:r>
                    <a:rPr lang="de-AT" sz="1000" baseline="30000">
                      <a:effectLst/>
                    </a:rPr>
                    <a:t>5 </a:t>
                  </a:r>
                  <a:r>
                    <a:rPr lang="de-AT" sz="1000" b="0" i="0" u="none" strike="noStrike" baseline="0">
                      <a:effectLst/>
                    </a:rPr>
                    <a:t>cells</a:t>
                  </a:r>
                  <a:r>
                    <a:rPr lang="de-AT" sz="1000">
                      <a:effectLst/>
                    </a:rPr>
                    <a:t>/ml</a:t>
                  </a:r>
                </a:p>
              </c:rich>
            </c:tx>
            <c:spPr>
              <a:noFill/>
              <a:ln>
                <a:noFill/>
              </a:ln>
              <a:effectLst/>
            </c:spPr>
            <c:txPr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</c:dispUnitsLbl>
        </c:dispUnits>
      </c:valAx>
      <c:valAx>
        <c:axId val="422154048"/>
        <c:scaling>
          <c:orientation val="minMax"/>
          <c:max val="4000000"/>
        </c:scaling>
        <c:delete val="1"/>
        <c:axPos val="r"/>
        <c:numFmt formatCode="General" sourceLinked="1"/>
        <c:majorTickMark val="out"/>
        <c:minorTickMark val="none"/>
        <c:tickLblPos val="nextTo"/>
        <c:crossAx val="422154704"/>
        <c:crosses val="max"/>
        <c:crossBetween val="midCat"/>
      </c:valAx>
      <c:valAx>
        <c:axId val="422154704"/>
        <c:scaling>
          <c:orientation val="minMax"/>
        </c:scaling>
        <c:delete val="1"/>
        <c:axPos val="t"/>
        <c:majorTickMark val="out"/>
        <c:minorTickMark val="none"/>
        <c:tickLblPos val="nextTo"/>
        <c:crossAx val="422154048"/>
        <c:crosses val="max"/>
        <c:crossBetween val="midCat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AT"/>
              <a:t>challenge control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lineChart>
        <c:grouping val="standard"/>
        <c:varyColors val="0"/>
        <c:ser>
          <c:idx val="5"/>
          <c:order val="5"/>
          <c:tx>
            <c:strRef>
              <c:f>'TCRgd graphs'!$Q$29</c:f>
              <c:strCache>
                <c:ptCount val="1"/>
                <c:pt idx="0">
                  <c:v>mean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'TCRgd graphs'!$R$23:$W$23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cat>
          <c:val>
            <c:numRef>
              <c:f>'TCRgd graphs'!$R$29:$W$29</c:f>
              <c:numCache>
                <c:formatCode>General</c:formatCode>
                <c:ptCount val="6"/>
                <c:pt idx="0">
                  <c:v>57479.509380000003</c:v>
                </c:pt>
                <c:pt idx="1">
                  <c:v>534559.88300000003</c:v>
                </c:pt>
                <c:pt idx="2">
                  <c:v>683248.08200000005</c:v>
                </c:pt>
                <c:pt idx="3">
                  <c:v>1849008.7</c:v>
                </c:pt>
                <c:pt idx="4">
                  <c:v>628388.75300000003</c:v>
                </c:pt>
                <c:pt idx="5">
                  <c:v>1276582.061666666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6D5-4676-8DB3-90C60A17882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08897448"/>
        <c:axId val="408897776"/>
      </c:lineChart>
      <c:scatterChart>
        <c:scatterStyle val="lineMarker"/>
        <c:varyColors val="0"/>
        <c:ser>
          <c:idx val="0"/>
          <c:order val="0"/>
          <c:tx>
            <c:strRef>
              <c:f>'TCRgd graphs'!$Q$24</c:f>
              <c:strCache>
                <c:ptCount val="1"/>
                <c:pt idx="0">
                  <c:v>11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strRef>
              <c:f>'TCRgd graphs'!$R$23:$W$23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TCRgd graphs'!$R$24:$W$24</c:f>
              <c:numCache>
                <c:formatCode>General</c:formatCode>
                <c:ptCount val="6"/>
                <c:pt idx="0">
                  <c:v>102231.36</c:v>
                </c:pt>
                <c:pt idx="1">
                  <c:v>526322.77500000002</c:v>
                </c:pt>
                <c:pt idx="2">
                  <c:v>596730.39999999991</c:v>
                </c:pt>
                <c:pt idx="3">
                  <c:v>1755432</c:v>
                </c:pt>
                <c:pt idx="4">
                  <c:v>536851.56000000006</c:v>
                </c:pt>
                <c:pt idx="5">
                  <c:v>1629580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B6D5-4676-8DB3-90C60A178822}"/>
            </c:ext>
          </c:extLst>
        </c:ser>
        <c:ser>
          <c:idx val="1"/>
          <c:order val="1"/>
          <c:tx>
            <c:strRef>
              <c:f>'TCRgd graphs'!$Q$25</c:f>
              <c:strCache>
                <c:ptCount val="1"/>
                <c:pt idx="0">
                  <c:v>12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strRef>
              <c:f>'TCRgd graphs'!$R$23:$W$23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TCRgd graphs'!$R$25:$W$25</c:f>
              <c:numCache>
                <c:formatCode>General</c:formatCode>
                <c:ptCount val="6"/>
                <c:pt idx="0">
                  <c:v>24050.063399999999</c:v>
                </c:pt>
                <c:pt idx="1">
                  <c:v>316601.59999999998</c:v>
                </c:pt>
                <c:pt idx="2">
                  <c:v>723168</c:v>
                </c:pt>
                <c:pt idx="3">
                  <c:v>1094344.3</c:v>
                </c:pt>
                <c:pt idx="4">
                  <c:v>670609.50000000012</c:v>
                </c:pt>
                <c:pt idx="5">
                  <c:v>337849.784999999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B6D5-4676-8DB3-90C60A178822}"/>
            </c:ext>
          </c:extLst>
        </c:ser>
        <c:ser>
          <c:idx val="2"/>
          <c:order val="2"/>
          <c:tx>
            <c:strRef>
              <c:f>'TCRgd graphs'!$Q$26</c:f>
              <c:strCache>
                <c:ptCount val="1"/>
                <c:pt idx="0">
                  <c:v>13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strRef>
              <c:f>'TCRgd graphs'!$R$23:$W$23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TCRgd graphs'!$R$26:$W$26</c:f>
              <c:numCache>
                <c:formatCode>General</c:formatCode>
                <c:ptCount val="6"/>
                <c:pt idx="0">
                  <c:v>46900.392</c:v>
                </c:pt>
                <c:pt idx="1">
                  <c:v>566292.72</c:v>
                </c:pt>
                <c:pt idx="2">
                  <c:v>912938.00000000012</c:v>
                </c:pt>
                <c:pt idx="3">
                  <c:v>1295935</c:v>
                </c:pt>
                <c:pt idx="4">
                  <c:v>553518.00000000012</c:v>
                </c:pt>
                <c:pt idx="5">
                  <c:v>186231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B6D5-4676-8DB3-90C60A178822}"/>
            </c:ext>
          </c:extLst>
        </c:ser>
        <c:ser>
          <c:idx val="3"/>
          <c:order val="3"/>
          <c:tx>
            <c:strRef>
              <c:f>'TCRgd graphs'!$Q$27</c:f>
              <c:strCache>
                <c:ptCount val="1"/>
                <c:pt idx="0">
                  <c:v>14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strRef>
              <c:f>'TCRgd graphs'!$R$23:$W$23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TCRgd graphs'!$R$27:$W$27</c:f>
              <c:numCache>
                <c:formatCode>General</c:formatCode>
                <c:ptCount val="6"/>
                <c:pt idx="0">
                  <c:v>40759.075500000006</c:v>
                </c:pt>
                <c:pt idx="1">
                  <c:v>668852.80000000005</c:v>
                </c:pt>
                <c:pt idx="2">
                  <c:v>609911.05000000005</c:v>
                </c:pt>
                <c:pt idx="3">
                  <c:v>3485559</c:v>
                </c:pt>
                <c:pt idx="4">
                  <c:v>82547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B6D5-4676-8DB3-90C60A178822}"/>
            </c:ext>
          </c:extLst>
        </c:ser>
        <c:ser>
          <c:idx val="4"/>
          <c:order val="4"/>
          <c:tx>
            <c:strRef>
              <c:f>'TCRgd graphs'!$Q$28</c:f>
              <c:strCache>
                <c:ptCount val="1"/>
                <c:pt idx="0">
                  <c:v>15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strRef>
              <c:f>'TCRgd graphs'!$R$23:$W$23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TCRgd graphs'!$R$28:$W$28</c:f>
              <c:numCache>
                <c:formatCode>General</c:formatCode>
                <c:ptCount val="6"/>
                <c:pt idx="0">
                  <c:v>73456.656000000003</c:v>
                </c:pt>
                <c:pt idx="1">
                  <c:v>594729.52</c:v>
                </c:pt>
                <c:pt idx="2">
                  <c:v>573492.96</c:v>
                </c:pt>
                <c:pt idx="3">
                  <c:v>1613773.2</c:v>
                </c:pt>
                <c:pt idx="4">
                  <c:v>555493.704999999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B6D5-4676-8DB3-90C60A17882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97452664"/>
        <c:axId val="497455944"/>
      </c:scatterChart>
      <c:catAx>
        <c:axId val="4088974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08897776"/>
        <c:crosses val="autoZero"/>
        <c:auto val="1"/>
        <c:lblAlgn val="ctr"/>
        <c:lblOffset val="100"/>
        <c:noMultiLvlLbl val="0"/>
      </c:catAx>
      <c:valAx>
        <c:axId val="408897776"/>
        <c:scaling>
          <c:orientation val="minMax"/>
          <c:max val="4000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08897448"/>
        <c:crosses val="autoZero"/>
        <c:crossBetween val="between"/>
        <c:majorUnit val="1000000"/>
        <c:dispUnits>
          <c:builtInUnit val="hundredThousands"/>
          <c:dispUnitsLbl>
            <c:layout>
              <c:manualLayout>
                <c:xMode val="edge"/>
                <c:yMode val="edge"/>
                <c:x val="2.1911663216011044E-2"/>
                <c:y val="0.38563156100886165"/>
              </c:manualLayout>
            </c:layout>
            <c:tx>
              <c:rich>
                <a:bodyPr rot="-5400000" spcFirstLastPara="1" vertOverflow="ellipsis" vert="horz" wrap="square" anchor="ctr" anchorCtr="1"/>
                <a:lstStyle/>
                <a:p>
                  <a:pPr>
                    <a:defRPr sz="10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r>
                    <a:rPr lang="de-AT" sz="1000">
                      <a:effectLst/>
                    </a:rPr>
                    <a:t>10</a:t>
                  </a:r>
                  <a:r>
                    <a:rPr lang="de-AT" sz="1000" baseline="30000">
                      <a:effectLst/>
                    </a:rPr>
                    <a:t>5 </a:t>
                  </a:r>
                  <a:r>
                    <a:rPr lang="de-AT" sz="1000" b="0" i="0" u="none" strike="noStrike" baseline="0">
                      <a:effectLst/>
                    </a:rPr>
                    <a:t>cells</a:t>
                  </a:r>
                  <a:r>
                    <a:rPr lang="de-AT" sz="1000">
                      <a:effectLst/>
                    </a:rPr>
                    <a:t>/ml</a:t>
                  </a:r>
                </a:p>
              </c:rich>
            </c:tx>
            <c:spPr>
              <a:noFill/>
              <a:ln>
                <a:noFill/>
              </a:ln>
              <a:effectLst/>
            </c:spPr>
            <c:txPr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</c:dispUnitsLbl>
        </c:dispUnits>
      </c:valAx>
      <c:valAx>
        <c:axId val="497455944"/>
        <c:scaling>
          <c:orientation val="minMax"/>
        </c:scaling>
        <c:delete val="1"/>
        <c:axPos val="r"/>
        <c:numFmt formatCode="General" sourceLinked="1"/>
        <c:majorTickMark val="out"/>
        <c:minorTickMark val="none"/>
        <c:tickLblPos val="nextTo"/>
        <c:crossAx val="497452664"/>
        <c:crosses val="max"/>
        <c:crossBetween val="midCat"/>
      </c:valAx>
      <c:valAx>
        <c:axId val="497452664"/>
        <c:scaling>
          <c:orientation val="minMax"/>
        </c:scaling>
        <c:delete val="1"/>
        <c:axPos val="t"/>
        <c:majorTickMark val="out"/>
        <c:minorTickMark val="none"/>
        <c:tickLblPos val="nextTo"/>
        <c:crossAx val="497455944"/>
        <c:crosses val="max"/>
        <c:crossBetween val="midCat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AT"/>
              <a:t>vaccinated/challenged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lineChart>
        <c:grouping val="standard"/>
        <c:varyColors val="0"/>
        <c:ser>
          <c:idx val="5"/>
          <c:order val="5"/>
          <c:tx>
            <c:strRef>
              <c:f>'TCRgd graphs'!$R$39</c:f>
              <c:strCache>
                <c:ptCount val="1"/>
                <c:pt idx="0">
                  <c:v>mean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'TCRgd graphs'!$S$33:$W$33</c:f>
              <c:strCache>
                <c:ptCount val="5"/>
                <c:pt idx="0">
                  <c:v>20 dpv</c:v>
                </c:pt>
                <c:pt idx="1">
                  <c:v>3 dpc</c:v>
                </c:pt>
                <c:pt idx="2">
                  <c:v>5 dpc</c:v>
                </c:pt>
                <c:pt idx="3">
                  <c:v>7 dpc</c:v>
                </c:pt>
                <c:pt idx="4">
                  <c:v>14 dpc</c:v>
                </c:pt>
              </c:strCache>
            </c:strRef>
          </c:cat>
          <c:val>
            <c:numRef>
              <c:f>'TCRgd graphs'!$S$39:$W$39</c:f>
              <c:numCache>
                <c:formatCode>General</c:formatCode>
                <c:ptCount val="5"/>
                <c:pt idx="0">
                  <c:v>798404.48800000013</c:v>
                </c:pt>
                <c:pt idx="1">
                  <c:v>1195045.892</c:v>
                </c:pt>
                <c:pt idx="2">
                  <c:v>483276.91</c:v>
                </c:pt>
                <c:pt idx="3">
                  <c:v>639101.28</c:v>
                </c:pt>
                <c:pt idx="4">
                  <c:v>427848.5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4D9-4DE1-A12F-99FF15AB9B4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46291360"/>
        <c:axId val="346291688"/>
      </c:lineChart>
      <c:scatterChart>
        <c:scatterStyle val="lineMarker"/>
        <c:varyColors val="0"/>
        <c:ser>
          <c:idx val="0"/>
          <c:order val="0"/>
          <c:tx>
            <c:strRef>
              <c:f>'TCRgd graphs'!$R$34</c:f>
              <c:strCache>
                <c:ptCount val="1"/>
                <c:pt idx="0">
                  <c:v>16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strRef>
              <c:f>'TCRgd graphs'!$S$33:$W$33</c:f>
              <c:strCache>
                <c:ptCount val="5"/>
                <c:pt idx="0">
                  <c:v>20 dpv</c:v>
                </c:pt>
                <c:pt idx="1">
                  <c:v>3 dpc</c:v>
                </c:pt>
                <c:pt idx="2">
                  <c:v>5 dpc</c:v>
                </c:pt>
                <c:pt idx="3">
                  <c:v>7 dpc</c:v>
                </c:pt>
                <c:pt idx="4">
                  <c:v>14 dpc</c:v>
                </c:pt>
              </c:strCache>
            </c:strRef>
          </c:xVal>
          <c:yVal>
            <c:numRef>
              <c:f>'TCRgd graphs'!$S$34:$W$34</c:f>
              <c:numCache>
                <c:formatCode>General</c:formatCode>
                <c:ptCount val="5"/>
                <c:pt idx="0">
                  <c:v>435056.16</c:v>
                </c:pt>
                <c:pt idx="1">
                  <c:v>1433360</c:v>
                </c:pt>
                <c:pt idx="2">
                  <c:v>543211.76</c:v>
                </c:pt>
                <c:pt idx="3">
                  <c:v>152343.84</c:v>
                </c:pt>
                <c:pt idx="4">
                  <c:v>484249.3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E4D9-4DE1-A12F-99FF15AB9B4A}"/>
            </c:ext>
          </c:extLst>
        </c:ser>
        <c:ser>
          <c:idx val="1"/>
          <c:order val="1"/>
          <c:tx>
            <c:strRef>
              <c:f>'TCRgd graphs'!$R$35</c:f>
              <c:strCache>
                <c:ptCount val="1"/>
                <c:pt idx="0">
                  <c:v>17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strRef>
              <c:f>'TCRgd graphs'!$S$33:$W$33</c:f>
              <c:strCache>
                <c:ptCount val="5"/>
                <c:pt idx="0">
                  <c:v>20 dpv</c:v>
                </c:pt>
                <c:pt idx="1">
                  <c:v>3 dpc</c:v>
                </c:pt>
                <c:pt idx="2">
                  <c:v>5 dpc</c:v>
                </c:pt>
                <c:pt idx="3">
                  <c:v>7 dpc</c:v>
                </c:pt>
                <c:pt idx="4">
                  <c:v>14 dpc</c:v>
                </c:pt>
              </c:strCache>
            </c:strRef>
          </c:xVal>
          <c:yVal>
            <c:numRef>
              <c:f>'TCRgd graphs'!$S$35:$W$35</c:f>
              <c:numCache>
                <c:formatCode>General</c:formatCode>
                <c:ptCount val="5"/>
                <c:pt idx="0">
                  <c:v>555326.80000000005</c:v>
                </c:pt>
                <c:pt idx="1">
                  <c:v>1594274.4</c:v>
                </c:pt>
                <c:pt idx="2">
                  <c:v>252625.158</c:v>
                </c:pt>
                <c:pt idx="3">
                  <c:v>473413.5</c:v>
                </c:pt>
                <c:pt idx="4">
                  <c:v>371447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E4D9-4DE1-A12F-99FF15AB9B4A}"/>
            </c:ext>
          </c:extLst>
        </c:ser>
        <c:ser>
          <c:idx val="2"/>
          <c:order val="2"/>
          <c:tx>
            <c:strRef>
              <c:f>'TCRgd graphs'!$R$36</c:f>
              <c:strCache>
                <c:ptCount val="1"/>
                <c:pt idx="0">
                  <c:v>18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strRef>
              <c:f>'TCRgd graphs'!$S$33:$W$33</c:f>
              <c:strCache>
                <c:ptCount val="5"/>
                <c:pt idx="0">
                  <c:v>20 dpv</c:v>
                </c:pt>
                <c:pt idx="1">
                  <c:v>3 dpc</c:v>
                </c:pt>
                <c:pt idx="2">
                  <c:v>5 dpc</c:v>
                </c:pt>
                <c:pt idx="3">
                  <c:v>7 dpc</c:v>
                </c:pt>
                <c:pt idx="4">
                  <c:v>14 dpc</c:v>
                </c:pt>
              </c:strCache>
            </c:strRef>
          </c:xVal>
          <c:yVal>
            <c:numRef>
              <c:f>'TCRgd graphs'!$S$36:$W$36</c:f>
              <c:numCache>
                <c:formatCode>General</c:formatCode>
                <c:ptCount val="5"/>
                <c:pt idx="0">
                  <c:v>1693381.2</c:v>
                </c:pt>
                <c:pt idx="1">
                  <c:v>1968252.0000000002</c:v>
                </c:pt>
                <c:pt idx="2">
                  <c:v>406351.84800000006</c:v>
                </c:pt>
                <c:pt idx="3">
                  <c:v>335235.159999999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E4D9-4DE1-A12F-99FF15AB9B4A}"/>
            </c:ext>
          </c:extLst>
        </c:ser>
        <c:ser>
          <c:idx val="3"/>
          <c:order val="3"/>
          <c:tx>
            <c:strRef>
              <c:f>'TCRgd graphs'!$R$37</c:f>
              <c:strCache>
                <c:ptCount val="1"/>
                <c:pt idx="0">
                  <c:v>19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strRef>
              <c:f>'TCRgd graphs'!$S$33:$W$33</c:f>
              <c:strCache>
                <c:ptCount val="5"/>
                <c:pt idx="0">
                  <c:v>20 dpv</c:v>
                </c:pt>
                <c:pt idx="1">
                  <c:v>3 dpc</c:v>
                </c:pt>
                <c:pt idx="2">
                  <c:v>5 dpc</c:v>
                </c:pt>
                <c:pt idx="3">
                  <c:v>7 dpc</c:v>
                </c:pt>
                <c:pt idx="4">
                  <c:v>14 dpc</c:v>
                </c:pt>
              </c:strCache>
            </c:strRef>
          </c:xVal>
          <c:yVal>
            <c:numRef>
              <c:f>'TCRgd graphs'!$S$37:$W$37</c:f>
              <c:numCache>
                <c:formatCode>General</c:formatCode>
                <c:ptCount val="5"/>
                <c:pt idx="0">
                  <c:v>726487.2</c:v>
                </c:pt>
                <c:pt idx="1">
                  <c:v>234134.18</c:v>
                </c:pt>
                <c:pt idx="2">
                  <c:v>315725.78400000004</c:v>
                </c:pt>
                <c:pt idx="3">
                  <c:v>983352.2999999998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E4D9-4DE1-A12F-99FF15AB9B4A}"/>
            </c:ext>
          </c:extLst>
        </c:ser>
        <c:ser>
          <c:idx val="4"/>
          <c:order val="4"/>
          <c:tx>
            <c:strRef>
              <c:f>'TCRgd graphs'!$R$38</c:f>
              <c:strCache>
                <c:ptCount val="1"/>
                <c:pt idx="0">
                  <c:v>20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strRef>
              <c:f>'TCRgd graphs'!$S$33:$W$33</c:f>
              <c:strCache>
                <c:ptCount val="5"/>
                <c:pt idx="0">
                  <c:v>20 dpv</c:v>
                </c:pt>
                <c:pt idx="1">
                  <c:v>3 dpc</c:v>
                </c:pt>
                <c:pt idx="2">
                  <c:v>5 dpc</c:v>
                </c:pt>
                <c:pt idx="3">
                  <c:v>7 dpc</c:v>
                </c:pt>
                <c:pt idx="4">
                  <c:v>14 dpc</c:v>
                </c:pt>
              </c:strCache>
            </c:strRef>
          </c:xVal>
          <c:yVal>
            <c:numRef>
              <c:f>'TCRgd graphs'!$S$38:$W$38</c:f>
              <c:numCache>
                <c:formatCode>General</c:formatCode>
                <c:ptCount val="5"/>
                <c:pt idx="0">
                  <c:v>581771.07999999996</c:v>
                </c:pt>
                <c:pt idx="1">
                  <c:v>745208.88</c:v>
                </c:pt>
                <c:pt idx="2">
                  <c:v>898470</c:v>
                </c:pt>
                <c:pt idx="3">
                  <c:v>1251161.6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E4D9-4DE1-A12F-99FF15AB9B4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54496808"/>
        <c:axId val="454493856"/>
      </c:scatterChart>
      <c:catAx>
        <c:axId val="3462913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346291688"/>
        <c:crosses val="autoZero"/>
        <c:auto val="1"/>
        <c:lblAlgn val="ctr"/>
        <c:lblOffset val="100"/>
        <c:noMultiLvlLbl val="0"/>
      </c:catAx>
      <c:valAx>
        <c:axId val="346291688"/>
        <c:scaling>
          <c:orientation val="minMax"/>
          <c:max val="4000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346291360"/>
        <c:crosses val="autoZero"/>
        <c:crossBetween val="between"/>
        <c:majorUnit val="1000000"/>
        <c:dispUnits>
          <c:builtInUnit val="hundredThousands"/>
          <c:dispUnitsLbl>
            <c:layout>
              <c:manualLayout>
                <c:xMode val="edge"/>
                <c:yMode val="edge"/>
                <c:x val="2.9215550954681389E-2"/>
                <c:y val="0.38563156100886165"/>
              </c:manualLayout>
            </c:layout>
            <c:tx>
              <c:rich>
                <a:bodyPr rot="-5400000" spcFirstLastPara="1" vertOverflow="ellipsis" vert="horz" wrap="square" anchor="ctr" anchorCtr="1"/>
                <a:lstStyle/>
                <a:p>
                  <a:pPr>
                    <a:defRPr sz="10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r>
                    <a:rPr lang="de-AT" sz="1000">
                      <a:effectLst/>
                    </a:rPr>
                    <a:t>10</a:t>
                  </a:r>
                  <a:r>
                    <a:rPr lang="de-AT" sz="1000" baseline="30000">
                      <a:effectLst/>
                    </a:rPr>
                    <a:t>5 </a:t>
                  </a:r>
                  <a:r>
                    <a:rPr lang="de-AT" sz="1000" b="0" i="0" u="none" strike="noStrike" baseline="0">
                      <a:effectLst/>
                    </a:rPr>
                    <a:t>cells</a:t>
                  </a:r>
                  <a:r>
                    <a:rPr lang="de-AT" sz="1000">
                      <a:effectLst/>
                    </a:rPr>
                    <a:t>/ml</a:t>
                  </a:r>
                </a:p>
              </c:rich>
            </c:tx>
            <c:spPr>
              <a:noFill/>
              <a:ln>
                <a:noFill/>
              </a:ln>
              <a:effectLst/>
            </c:spPr>
            <c:txPr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</c:dispUnitsLbl>
        </c:dispUnits>
      </c:valAx>
      <c:valAx>
        <c:axId val="454493856"/>
        <c:scaling>
          <c:orientation val="minMax"/>
          <c:max val="4000000"/>
        </c:scaling>
        <c:delete val="1"/>
        <c:axPos val="r"/>
        <c:numFmt formatCode="General" sourceLinked="1"/>
        <c:majorTickMark val="out"/>
        <c:minorTickMark val="none"/>
        <c:tickLblPos val="nextTo"/>
        <c:crossAx val="454496808"/>
        <c:crosses val="max"/>
        <c:crossBetween val="midCat"/>
      </c:valAx>
      <c:valAx>
        <c:axId val="454496808"/>
        <c:scaling>
          <c:orientation val="minMax"/>
        </c:scaling>
        <c:delete val="1"/>
        <c:axPos val="t"/>
        <c:majorTickMark val="out"/>
        <c:minorTickMark val="none"/>
        <c:tickLblPos val="nextTo"/>
        <c:crossAx val="454493856"/>
        <c:crosses val="max"/>
        <c:crossBetween val="midCat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46294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52533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74029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16784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1903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37033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31989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70892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96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05483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49326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67036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337393" y="181408"/>
            <a:ext cx="11122295" cy="6313323"/>
            <a:chOff x="337393" y="181408"/>
            <a:chExt cx="11122295" cy="6313323"/>
          </a:xfrm>
        </p:grpSpPr>
        <p:grpSp>
          <p:nvGrpSpPr>
            <p:cNvPr id="3" name="Group 2"/>
            <p:cNvGrpSpPr/>
            <p:nvPr/>
          </p:nvGrpSpPr>
          <p:grpSpPr>
            <a:xfrm>
              <a:off x="337393" y="181408"/>
              <a:ext cx="11122295" cy="6313323"/>
              <a:chOff x="337393" y="181408"/>
              <a:chExt cx="11122295" cy="6313323"/>
            </a:xfrm>
          </p:grpSpPr>
          <p:grpSp>
            <p:nvGrpSpPr>
              <p:cNvPr id="2" name="Group 1"/>
              <p:cNvGrpSpPr/>
              <p:nvPr/>
            </p:nvGrpSpPr>
            <p:grpSpPr>
              <a:xfrm>
                <a:off x="375406" y="218768"/>
                <a:ext cx="11084282" cy="6275963"/>
                <a:chOff x="375406" y="218768"/>
                <a:chExt cx="11084282" cy="6275963"/>
              </a:xfrm>
            </p:grpSpPr>
            <p:graphicFrame>
              <p:nvGraphicFramePr>
                <p:cNvPr id="21" name="Chart 20"/>
                <p:cNvGraphicFramePr/>
                <p:nvPr>
                  <p:extLst>
                    <p:ext uri="{D42A27DB-BD31-4B8C-83A1-F6EECF244321}">
                      <p14:modId xmlns:p14="http://schemas.microsoft.com/office/powerpoint/2010/main" val="1533289716"/>
                    </p:ext>
                  </p:extLst>
                </p:nvPr>
              </p:nvGraphicFramePr>
              <p:xfrm>
                <a:off x="375406" y="218768"/>
                <a:ext cx="5216400" cy="2934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graphicFrame>
              <p:nvGraphicFramePr>
                <p:cNvPr id="22" name="Chart 21"/>
                <p:cNvGraphicFramePr/>
                <p:nvPr>
                  <p:extLst>
                    <p:ext uri="{D42A27DB-BD31-4B8C-83A1-F6EECF244321}">
                      <p14:modId xmlns:p14="http://schemas.microsoft.com/office/powerpoint/2010/main" val="3426974812"/>
                    </p:ext>
                  </p:extLst>
                </p:nvPr>
              </p:nvGraphicFramePr>
              <p:xfrm>
                <a:off x="6243288" y="218768"/>
                <a:ext cx="5216400" cy="2934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graphicFrame>
              <p:nvGraphicFramePr>
                <p:cNvPr id="24" name="Chart 23"/>
                <p:cNvGraphicFramePr/>
                <p:nvPr>
                  <p:extLst>
                    <p:ext uri="{D42A27DB-BD31-4B8C-83A1-F6EECF244321}">
                      <p14:modId xmlns:p14="http://schemas.microsoft.com/office/powerpoint/2010/main" val="2304120639"/>
                    </p:ext>
                  </p:extLst>
                </p:nvPr>
              </p:nvGraphicFramePr>
              <p:xfrm>
                <a:off x="375406" y="3560731"/>
                <a:ext cx="5216400" cy="2934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"/>
                </a:graphicData>
              </a:graphic>
            </p:graphicFrame>
            <p:graphicFrame>
              <p:nvGraphicFramePr>
                <p:cNvPr id="25" name="Chart 24"/>
                <p:cNvGraphicFramePr/>
                <p:nvPr>
                  <p:extLst>
                    <p:ext uri="{D42A27DB-BD31-4B8C-83A1-F6EECF244321}">
                      <p14:modId xmlns:p14="http://schemas.microsoft.com/office/powerpoint/2010/main" val="1958550690"/>
                    </p:ext>
                  </p:extLst>
                </p:nvPr>
              </p:nvGraphicFramePr>
              <p:xfrm>
                <a:off x="6243288" y="3560731"/>
                <a:ext cx="5216400" cy="2934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5"/>
                </a:graphicData>
              </a:graphic>
            </p:graphicFrame>
          </p:grpSp>
          <p:sp>
            <p:nvSpPr>
              <p:cNvPr id="8" name="TextBox 7"/>
              <p:cNvSpPr txBox="1"/>
              <p:nvPr/>
            </p:nvSpPr>
            <p:spPr>
              <a:xfrm>
                <a:off x="337393" y="181408"/>
                <a:ext cx="31143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dirty="0"/>
                  <a:t>A</a:t>
                </a: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6185622" y="181408"/>
                <a:ext cx="31143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dirty="0" smtClean="0"/>
                  <a:t>B</a:t>
                </a:r>
                <a:endParaRPr lang="en-GB" dirty="0"/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337393" y="3560731"/>
                <a:ext cx="31143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dirty="0" smtClean="0"/>
                  <a:t>C</a:t>
                </a:r>
                <a:endParaRPr lang="en-GB" dirty="0"/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6185622" y="3560731"/>
                <a:ext cx="31143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dirty="0" smtClean="0"/>
                  <a:t>D</a:t>
                </a:r>
                <a:endParaRPr lang="en-GB" dirty="0"/>
              </a:p>
            </p:txBody>
          </p:sp>
        </p:grpSp>
        <p:sp>
          <p:nvSpPr>
            <p:cNvPr id="23" name="TextBox 22"/>
            <p:cNvSpPr txBox="1"/>
            <p:nvPr/>
          </p:nvSpPr>
          <p:spPr>
            <a:xfrm>
              <a:off x="8594222" y="1448350"/>
              <a:ext cx="180756" cy="2868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de-AT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9352558" y="1679400"/>
              <a:ext cx="180756" cy="2868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de-AT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4233838" y="5251236"/>
              <a:ext cx="180756" cy="2868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de-AT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7177077" y="4843118"/>
              <a:ext cx="180756" cy="2868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de-AT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3486525" y="4007582"/>
              <a:ext cx="180756" cy="2868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de-AT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2729099" y="5201250"/>
              <a:ext cx="180756" cy="2868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de-AT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1987239" y="5321841"/>
              <a:ext cx="180756" cy="2868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de-AT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3591970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明朝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明朝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明朝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明朝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Calibri</vt:lpstr>
      <vt:lpstr>Calibri Light</vt:lpstr>
      <vt:lpstr>Times New Roman</vt:lpstr>
      <vt:lpstr>Arial</vt:lpstr>
      <vt:lpstr>Office Theme</vt:lpstr>
      <vt:lpstr>PowerPoint Presentation</vt:lpstr>
    </vt:vector>
  </TitlesOfParts>
  <Company>Vetmeduni Vienn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 Luca Carlotta</dc:creator>
  <cp:lastModifiedBy>De Luca Carlotta</cp:lastModifiedBy>
  <cp:revision>10</cp:revision>
  <dcterms:created xsi:type="dcterms:W3CDTF">2020-07-30T11:05:44Z</dcterms:created>
  <dcterms:modified xsi:type="dcterms:W3CDTF">2020-07-30T12:25:26Z</dcterms:modified>
</cp:coreProperties>
</file>